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726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921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351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556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274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8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765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10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457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07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323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778E8-DE6C-4686-A94E-C8C0674CA979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34F3F-5254-4C5A-8F99-5D740F8BA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043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jpeg"/><Relationship Id="rId26" Type="http://schemas.openxmlformats.org/officeDocument/2006/relationships/image" Target="../media/image25.emf"/><Relationship Id="rId21" Type="http://schemas.openxmlformats.org/officeDocument/2006/relationships/image" Target="../media/image20.jpeg"/><Relationship Id="rId34" Type="http://schemas.openxmlformats.org/officeDocument/2006/relationships/image" Target="../media/image33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eg"/><Relationship Id="rId38" Type="http://schemas.openxmlformats.org/officeDocument/2006/relationships/image" Target="../media/image37.jpg"/><Relationship Id="rId2" Type="http://schemas.openxmlformats.org/officeDocument/2006/relationships/image" Target="../media/image1.pn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5.emf"/><Relationship Id="rId10" Type="http://schemas.openxmlformats.org/officeDocument/2006/relationships/image" Target="../media/image9.pn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emf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jpe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3556"/>
            <a:ext cx="3057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ie et al, Supplementary Figure 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>
            <a:grpSpLocks noChangeAspect="1"/>
          </p:cNvGrpSpPr>
          <p:nvPr/>
        </p:nvGrpSpPr>
        <p:grpSpPr>
          <a:xfrm>
            <a:off x="141715" y="420556"/>
            <a:ext cx="3293136" cy="2814483"/>
            <a:chOff x="124495" y="679500"/>
            <a:chExt cx="2474653" cy="2114969"/>
          </a:xfrm>
        </p:grpSpPr>
        <p:grpSp>
          <p:nvGrpSpPr>
            <p:cNvPr id="6" name="Group 5"/>
            <p:cNvGrpSpPr>
              <a:grpSpLocks noChangeAspect="1"/>
            </p:cNvGrpSpPr>
            <p:nvPr/>
          </p:nvGrpSpPr>
          <p:grpSpPr>
            <a:xfrm>
              <a:off x="277511" y="795703"/>
              <a:ext cx="2317951" cy="1693800"/>
              <a:chOff x="-107498" y="1156648"/>
              <a:chExt cx="7726504" cy="5646000"/>
            </a:xfrm>
          </p:grpSpPr>
          <p:pic>
            <p:nvPicPr>
              <p:cNvPr id="9" name="Picture 3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-80202" y="1156648"/>
                <a:ext cx="1886400" cy="1835748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0" name="Picture 4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-93850" y="3061648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1" name="Picture 5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-107498" y="4953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2" name="Picture 6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846406" y="1156648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3" name="Picture 7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846406" y="3048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4" name="Picture 8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832758" y="4953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5" name="Picture 9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792350" y="1156648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6" name="Picture 10"/>
              <p:cNvPicPr preferRelativeResize="0">
                <a:picLocks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778702" y="3048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7" name="Picture 11"/>
              <p:cNvPicPr preferRelativeResize="0">
                <a:picLocks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3759366" y="4953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8" name="Picture 12"/>
              <p:cNvPicPr preferRelativeResize="0">
                <a:picLocks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5732606" y="1156648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19" name="Picture 13"/>
              <p:cNvPicPr preferRelativeResize="0">
                <a:picLocks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5705310" y="3048000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  <p:pic>
            <p:nvPicPr>
              <p:cNvPr id="20" name="Picture 14"/>
              <p:cNvPicPr preferRelativeResize="0">
                <a:picLocks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5705310" y="4966648"/>
                <a:ext cx="1886400" cy="1836000"/>
              </a:xfrm>
              <a:prstGeom prst="ellipse">
                <a:avLst/>
              </a:prstGeom>
              <a:ln w="63500" cap="rnd">
                <a:noFill/>
              </a:ln>
              <a:effectLst/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439387" y="2493803"/>
              <a:ext cx="2159761" cy="300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1                    2                     3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677615" y="1481610"/>
              <a:ext cx="1789245" cy="185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3592156" y="520502"/>
            <a:ext cx="3180357" cy="2407376"/>
            <a:chOff x="2796514" y="784294"/>
            <a:chExt cx="3180357" cy="2407376"/>
          </a:xfrm>
        </p:grpSpPr>
        <p:sp>
          <p:nvSpPr>
            <p:cNvPr id="22" name="TextBox 21"/>
            <p:cNvSpPr txBox="1"/>
            <p:nvPr/>
          </p:nvSpPr>
          <p:spPr>
            <a:xfrm>
              <a:off x="2796514" y="784294"/>
              <a:ext cx="483987" cy="2092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pic>
          <p:nvPicPr>
            <p:cNvPr id="23" name="Picture 22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4" t="10371" r="6342" b="31394"/>
            <a:stretch/>
          </p:blipFill>
          <p:spPr bwMode="auto">
            <a:xfrm>
              <a:off x="3128213" y="794086"/>
              <a:ext cx="2848658" cy="20203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4" name="Group 23"/>
            <p:cNvGrpSpPr/>
            <p:nvPr/>
          </p:nvGrpSpPr>
          <p:grpSpPr>
            <a:xfrm>
              <a:off x="3239241" y="1913909"/>
              <a:ext cx="1697974" cy="863701"/>
              <a:chOff x="2072251" y="2858967"/>
              <a:chExt cx="1697974" cy="863701"/>
            </a:xfrm>
          </p:grpSpPr>
          <p:grpSp>
            <p:nvGrpSpPr>
              <p:cNvPr id="28" name="Group 27"/>
              <p:cNvGrpSpPr>
                <a:grpSpLocks noChangeAspect="1"/>
              </p:cNvGrpSpPr>
              <p:nvPr/>
            </p:nvGrpSpPr>
            <p:grpSpPr>
              <a:xfrm>
                <a:off x="2072251" y="3095944"/>
                <a:ext cx="1000678" cy="395220"/>
                <a:chOff x="2072251" y="3095944"/>
                <a:chExt cx="1968254" cy="777366"/>
              </a:xfrm>
            </p:grpSpPr>
            <p:pic>
              <p:nvPicPr>
                <p:cNvPr id="32" name="Picture 2" descr="C:\Documents and Settings\Jia Xie\Desktop\CAOV-3 WB\cx3cr1.jpg"/>
                <p:cNvPicPr preferRelativeResize="0">
                  <a:picLocks noChangeArrowheads="1"/>
                </p:cNvPicPr>
                <p:nvPr/>
              </p:nvPicPr>
              <p:blipFill>
                <a:blip r:embed="rId15" cstate="print"/>
                <a:srcRect/>
                <a:stretch>
                  <a:fillRect/>
                </a:stretch>
              </p:blipFill>
              <p:spPr bwMode="auto">
                <a:xfrm>
                  <a:off x="2074545" y="3095944"/>
                  <a:ext cx="1965960" cy="356616"/>
                </a:xfrm>
                <a:prstGeom prst="rect">
                  <a:avLst/>
                </a:prstGeom>
                <a:noFill/>
                <a:ln>
                  <a:solidFill>
                    <a:sysClr val="windowText" lastClr="000000"/>
                  </a:solidFill>
                </a:ln>
              </p:spPr>
            </p:pic>
            <p:pic>
              <p:nvPicPr>
                <p:cNvPr id="33" name="Picture 3" descr="C:\Documents and Settings\Jia Xie\Desktop\CAOV-3 WB\GAPDH-cx3cr1.jpg"/>
                <p:cNvPicPr preferRelativeResize="0">
                  <a:picLocks noChangeArrowheads="1"/>
                </p:cNvPicPr>
                <p:nvPr/>
              </p:nvPicPr>
              <p:blipFill>
                <a:blip r:embed="rId16" cstate="print"/>
                <a:srcRect/>
                <a:stretch>
                  <a:fillRect/>
                </a:stretch>
              </p:blipFill>
              <p:spPr bwMode="auto">
                <a:xfrm>
                  <a:off x="2072251" y="3516694"/>
                  <a:ext cx="1965960" cy="356616"/>
                </a:xfrm>
                <a:prstGeom prst="rect">
                  <a:avLst/>
                </a:prstGeom>
                <a:noFill/>
                <a:ln>
                  <a:solidFill>
                    <a:sysClr val="windowText" lastClr="000000"/>
                  </a:solidFill>
                </a:ln>
              </p:spPr>
            </p:pic>
          </p:grpSp>
          <p:sp>
            <p:nvSpPr>
              <p:cNvPr id="29" name="TextBox 28"/>
              <p:cNvSpPr txBox="1"/>
              <p:nvPr/>
            </p:nvSpPr>
            <p:spPr>
              <a:xfrm>
                <a:off x="3057525" y="3095944"/>
                <a:ext cx="71270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X</a:t>
                </a:r>
                <a:r>
                  <a:rPr lang="en-US" sz="10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R1</a:t>
                </a:r>
              </a:p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109070" y="2858967"/>
                <a:ext cx="13883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trlsi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CX</a:t>
                </a:r>
                <a:r>
                  <a:rPr lang="en-US" sz="10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R1si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085314" y="3476447"/>
                <a:ext cx="14645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   98    15     %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4872426" y="910641"/>
              <a:ext cx="1038225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●NT</a:t>
              </a: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○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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051343" y="2791560"/>
              <a:ext cx="285930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1                     2                    3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2227171" y="1703679"/>
              <a:ext cx="15906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ing Fract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-24004" y="323385"/>
            <a:ext cx="15613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ov-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ight Bracket 34"/>
          <p:cNvSpPr/>
          <p:nvPr/>
        </p:nvSpPr>
        <p:spPr>
          <a:xfrm>
            <a:off x="6379252" y="1545588"/>
            <a:ext cx="45719" cy="10452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ight Bracket 35"/>
          <p:cNvSpPr/>
          <p:nvPr/>
        </p:nvSpPr>
        <p:spPr>
          <a:xfrm>
            <a:off x="6431696" y="1615432"/>
            <a:ext cx="64947" cy="65216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6315668" y="1836088"/>
            <a:ext cx="48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89252" y="3274302"/>
            <a:ext cx="2591046" cy="2915652"/>
            <a:chOff x="89252" y="3847604"/>
            <a:chExt cx="2591046" cy="2915652"/>
          </a:xfrm>
        </p:grpSpPr>
        <p:grpSp>
          <p:nvGrpSpPr>
            <p:cNvPr id="39" name="Group 38"/>
            <p:cNvGrpSpPr>
              <a:grpSpLocks noChangeAspect="1"/>
            </p:cNvGrpSpPr>
            <p:nvPr/>
          </p:nvGrpSpPr>
          <p:grpSpPr>
            <a:xfrm>
              <a:off x="310238" y="4110781"/>
              <a:ext cx="2292258" cy="2258400"/>
              <a:chOff x="574932" y="2691061"/>
              <a:chExt cx="2890163" cy="2847474"/>
            </a:xfrm>
          </p:grpSpPr>
          <p:sp>
            <p:nvSpPr>
              <p:cNvPr id="42" name="Text Box 3"/>
              <p:cNvSpPr txBox="1">
                <a:spLocks noChangeArrowheads="1"/>
              </p:cNvSpPr>
              <p:nvPr/>
            </p:nvSpPr>
            <p:spPr bwMode="auto">
              <a:xfrm>
                <a:off x="1407227" y="3154025"/>
                <a:ext cx="183055" cy="3667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pic>
            <p:nvPicPr>
              <p:cNvPr id="43" name="Picture 42" descr="C:\Users\Athena\Desktop\PHOTO NEW\IMG_1481.JPG"/>
              <p:cNvPicPr preferRelativeResize="0">
                <a:picLocks noChangeArrowheads="1"/>
              </p:cNvPicPr>
              <p:nvPr/>
            </p:nvPicPr>
            <p:blipFill>
              <a:blip r:embed="rId17" cstate="print"/>
              <a:srcRect l="5250" t="5983" r="6814" b="5949"/>
              <a:stretch>
                <a:fillRect/>
              </a:stretch>
            </p:blipFill>
            <p:spPr bwMode="auto">
              <a:xfrm>
                <a:off x="574932" y="2711113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4" name="Picture 43" descr="C:\Users\Athena\Desktop\PHOTO NEW\IMG_1483.JPG"/>
              <p:cNvPicPr preferRelativeResize="0">
                <a:picLocks noChangeArrowheads="1"/>
              </p:cNvPicPr>
              <p:nvPr/>
            </p:nvPicPr>
            <p:blipFill>
              <a:blip r:embed="rId18" cstate="print"/>
              <a:srcRect l="6562" t="5325" r="4189" b="2812"/>
              <a:stretch>
                <a:fillRect/>
              </a:stretch>
            </p:blipFill>
            <p:spPr bwMode="auto">
              <a:xfrm>
                <a:off x="574932" y="3677650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5" name="Picture 44" descr="C:\Users\Athena\Desktop\PHOTO NEW\IMG_1485.JPG"/>
              <p:cNvPicPr preferRelativeResize="0">
                <a:picLocks noChangeArrowheads="1"/>
              </p:cNvPicPr>
              <p:nvPr/>
            </p:nvPicPr>
            <p:blipFill>
              <a:blip r:embed="rId19" cstate="print"/>
              <a:srcRect l="5250" t="7790" r="4189" b="2629"/>
              <a:stretch>
                <a:fillRect/>
              </a:stretch>
            </p:blipFill>
            <p:spPr bwMode="auto">
              <a:xfrm>
                <a:off x="574932" y="4620124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6" name="Picture 45" descr="C:\Users\Athena\Desktop\PHOTO NEW\IMG_1488.JPG"/>
              <p:cNvPicPr preferRelativeResize="0">
                <a:picLocks noChangeArrowheads="1"/>
              </p:cNvPicPr>
              <p:nvPr/>
            </p:nvPicPr>
            <p:blipFill>
              <a:blip r:embed="rId20" cstate="print"/>
              <a:srcRect l="7875" t="5480" r="6814" b="5473"/>
              <a:stretch>
                <a:fillRect/>
              </a:stretch>
            </p:blipFill>
            <p:spPr bwMode="auto">
              <a:xfrm>
                <a:off x="1565532" y="2691061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7" name="Picture 46" descr="C:\Users\Athena\Desktop\PHOTO NEW\IMG_1490.JPG"/>
              <p:cNvPicPr preferRelativeResize="0">
                <a:picLocks noChangeArrowheads="1"/>
              </p:cNvPicPr>
              <p:nvPr/>
            </p:nvPicPr>
            <p:blipFill>
              <a:blip r:embed="rId21" cstate="print"/>
              <a:srcRect l="6562" t="8050" r="6814" b="3400"/>
              <a:stretch>
                <a:fillRect/>
              </a:stretch>
            </p:blipFill>
            <p:spPr bwMode="auto">
              <a:xfrm>
                <a:off x="1565532" y="3657598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8" name="Picture 47" descr="C:\Users\Athena\Desktop\PHOTO NEW\IMG_1493.JPG"/>
              <p:cNvPicPr preferRelativeResize="0">
                <a:picLocks noChangeArrowheads="1"/>
              </p:cNvPicPr>
              <p:nvPr/>
            </p:nvPicPr>
            <p:blipFill>
              <a:blip r:embed="rId22" cstate="print"/>
              <a:srcRect l="6562" t="5262" r="4189" b="5276"/>
              <a:stretch>
                <a:fillRect/>
              </a:stretch>
            </p:blipFill>
            <p:spPr bwMode="auto">
              <a:xfrm>
                <a:off x="1565532" y="4624135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49" name="Picture 48" descr="C:\Users\Athena\Desktop\PHOTO NEW\IMG_1495.JPG"/>
              <p:cNvPicPr preferRelativeResize="0">
                <a:picLocks noChangeArrowheads="1"/>
              </p:cNvPicPr>
              <p:nvPr/>
            </p:nvPicPr>
            <p:blipFill>
              <a:blip r:embed="rId23" cstate="print"/>
              <a:srcRect l="5250" t="5310" r="4189" b="3087"/>
              <a:stretch>
                <a:fillRect/>
              </a:stretch>
            </p:blipFill>
            <p:spPr bwMode="auto">
              <a:xfrm>
                <a:off x="2556132" y="2691061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50" name="Picture 49" descr="C:\Users\Athena\Desktop\PHOTO NEW\IMG_1502.JPG"/>
              <p:cNvPicPr preferRelativeResize="0">
                <a:picLocks noChangeArrowheads="1"/>
              </p:cNvPicPr>
              <p:nvPr/>
            </p:nvPicPr>
            <p:blipFill>
              <a:blip r:embed="rId24" cstate="print"/>
              <a:srcRect l="7875" t="5745" r="10751" b="5201"/>
              <a:stretch>
                <a:fillRect/>
              </a:stretch>
            </p:blipFill>
            <p:spPr bwMode="auto">
              <a:xfrm>
                <a:off x="2556132" y="3657598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51" name="Picture 50" descr="C:\Users\Athena\Desktop\PHOTO NEW\IMG_1504.JPG"/>
              <p:cNvPicPr preferRelativeResize="0">
                <a:picLocks noChangeArrowheads="1"/>
              </p:cNvPicPr>
              <p:nvPr/>
            </p:nvPicPr>
            <p:blipFill>
              <a:blip r:embed="rId25" cstate="print"/>
              <a:srcRect l="6562" t="6872" r="4189" b="3455"/>
              <a:stretch>
                <a:fillRect/>
              </a:stretch>
            </p:blipFill>
            <p:spPr bwMode="auto">
              <a:xfrm>
                <a:off x="2556132" y="4624135"/>
                <a:ext cx="908963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</p:grpSp>
        <p:sp>
          <p:nvSpPr>
            <p:cNvPr id="40" name="TextBox 39"/>
            <p:cNvSpPr txBox="1"/>
            <p:nvPr/>
          </p:nvSpPr>
          <p:spPr>
            <a:xfrm>
              <a:off x="520537" y="6363146"/>
              <a:ext cx="215976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3                     7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-1049730" y="4986586"/>
              <a:ext cx="2524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590187" y="3559824"/>
            <a:ext cx="3151018" cy="2405396"/>
            <a:chOff x="2782664" y="4204376"/>
            <a:chExt cx="3151018" cy="2405396"/>
          </a:xfrm>
        </p:grpSpPr>
        <p:pic>
          <p:nvPicPr>
            <p:cNvPr id="53" name="Picture 52"/>
            <p:cNvPicPr>
              <a:picLocks noChangeAspect="1" noChangeArrowheads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59" t="8907" r="7084" b="32761"/>
            <a:stretch/>
          </p:blipFill>
          <p:spPr bwMode="auto">
            <a:xfrm>
              <a:off x="3128210" y="4204376"/>
              <a:ext cx="2805472" cy="20636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4" name="TextBox 53"/>
            <p:cNvSpPr txBox="1"/>
            <p:nvPr/>
          </p:nvSpPr>
          <p:spPr>
            <a:xfrm>
              <a:off x="4882321" y="4328741"/>
              <a:ext cx="1038225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●NT</a:t>
              </a: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○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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037489" y="6209662"/>
              <a:ext cx="285930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        3                                   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6200000">
              <a:off x="2237071" y="5145537"/>
              <a:ext cx="15906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ing Fract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782664" y="4249910"/>
              <a:ext cx="483987" cy="2092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99152" y="6272809"/>
            <a:ext cx="2602915" cy="2891892"/>
            <a:chOff x="99152" y="8358237"/>
            <a:chExt cx="2602915" cy="2891892"/>
          </a:xfrm>
        </p:grpSpPr>
        <p:grpSp>
          <p:nvGrpSpPr>
            <p:cNvPr id="66" name="Group 65"/>
            <p:cNvGrpSpPr>
              <a:grpSpLocks noChangeAspect="1"/>
            </p:cNvGrpSpPr>
            <p:nvPr/>
          </p:nvGrpSpPr>
          <p:grpSpPr>
            <a:xfrm>
              <a:off x="328868" y="8598563"/>
              <a:ext cx="2296570" cy="2258400"/>
              <a:chOff x="425120" y="6047871"/>
              <a:chExt cx="2895600" cy="2847474"/>
            </a:xfrm>
          </p:grpSpPr>
          <p:pic>
            <p:nvPicPr>
              <p:cNvPr id="69" name="Picture 2" descr="C:\Users\Athena\Desktop\PHOTO NEW\IMG_1455.JPG"/>
              <p:cNvPicPr preferRelativeResize="0">
                <a:picLocks noChangeArrowheads="1"/>
              </p:cNvPicPr>
              <p:nvPr/>
            </p:nvPicPr>
            <p:blipFill>
              <a:blip r:embed="rId27" cstate="print"/>
              <a:srcRect l="2625" t="3863" r="4189" b="3417"/>
              <a:stretch>
                <a:fillRect/>
              </a:stretch>
            </p:blipFill>
            <p:spPr bwMode="auto">
              <a:xfrm>
                <a:off x="425120" y="6047871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0" name="Picture 3" descr="C:\Users\Athena\Desktop\PHOTO NEW\IMG_1457.JPG"/>
              <p:cNvPicPr preferRelativeResize="0">
                <a:picLocks noChangeArrowheads="1"/>
              </p:cNvPicPr>
              <p:nvPr/>
            </p:nvPicPr>
            <p:blipFill>
              <a:blip r:embed="rId28" cstate="print"/>
              <a:srcRect l="5250" t="6572" r="4189" b="2735"/>
              <a:stretch>
                <a:fillRect/>
              </a:stretch>
            </p:blipFill>
            <p:spPr bwMode="auto">
              <a:xfrm>
                <a:off x="425120" y="7014408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1" name="Picture 4" descr="C:\Users\Athena\Desktop\PHOTO NEW\IMG_1459.JPG"/>
              <p:cNvPicPr preferRelativeResize="0">
                <a:picLocks noChangeArrowheads="1"/>
              </p:cNvPicPr>
              <p:nvPr/>
            </p:nvPicPr>
            <p:blipFill>
              <a:blip r:embed="rId29" cstate="print"/>
              <a:srcRect l="2625" t="3978" r="4189" b="3211"/>
              <a:stretch>
                <a:fillRect/>
              </a:stretch>
            </p:blipFill>
            <p:spPr bwMode="auto">
              <a:xfrm>
                <a:off x="425120" y="7980945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2" name="Picture 5" descr="C:\Users\Athena\Desktop\PHOTO NEW\IMG_1461.JPG"/>
              <p:cNvPicPr preferRelativeResize="0">
                <a:picLocks noChangeArrowheads="1"/>
              </p:cNvPicPr>
              <p:nvPr/>
            </p:nvPicPr>
            <p:blipFill>
              <a:blip r:embed="rId30" cstate="print"/>
              <a:srcRect l="2625" t="2646" r="4189" b="3418"/>
              <a:stretch>
                <a:fillRect/>
              </a:stretch>
            </p:blipFill>
            <p:spPr bwMode="auto">
              <a:xfrm>
                <a:off x="1415720" y="6047871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3" name="Picture 6" descr="C:\Users\Athena\Desktop\PHOTO NEW\IMG_1463.JPG"/>
              <p:cNvPicPr preferRelativeResize="0">
                <a:picLocks noChangeArrowheads="1"/>
              </p:cNvPicPr>
              <p:nvPr/>
            </p:nvPicPr>
            <p:blipFill>
              <a:blip r:embed="rId31" cstate="print"/>
              <a:srcRect l="3937" t="5260" r="4189" b="2698"/>
              <a:stretch>
                <a:fillRect/>
              </a:stretch>
            </p:blipFill>
            <p:spPr bwMode="auto">
              <a:xfrm>
                <a:off x="1415720" y="7014408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4" name="Picture 7" descr="C:\Users\Athena\Desktop\PHOTO NEW\IMG_1465.JPG"/>
              <p:cNvPicPr preferRelativeResize="0">
                <a:picLocks noChangeArrowheads="1"/>
              </p:cNvPicPr>
              <p:nvPr/>
            </p:nvPicPr>
            <p:blipFill>
              <a:blip r:embed="rId32" cstate="print"/>
              <a:srcRect l="1312" t="3887" r="4189" b="4132"/>
              <a:stretch>
                <a:fillRect/>
              </a:stretch>
            </p:blipFill>
            <p:spPr bwMode="auto">
              <a:xfrm>
                <a:off x="1415720" y="7980945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5" name="Picture 8" descr="C:\Users\Athena\Desktop\PHOTO NEW\IMG_1467.JPG"/>
              <p:cNvPicPr preferRelativeResize="0">
                <a:picLocks noChangeArrowheads="1"/>
              </p:cNvPicPr>
              <p:nvPr/>
            </p:nvPicPr>
            <p:blipFill>
              <a:blip r:embed="rId33" cstate="print"/>
              <a:srcRect l="4212" t="7722" r="3914" b="3526"/>
              <a:stretch>
                <a:fillRect/>
              </a:stretch>
            </p:blipFill>
            <p:spPr bwMode="auto">
              <a:xfrm>
                <a:off x="2406320" y="6047871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6" name="Picture 9" descr="C:\Users\Athena\Desktop\PHOTO NEW\IMG_1469.JPG"/>
              <p:cNvPicPr preferRelativeResize="0">
                <a:picLocks noChangeArrowheads="1"/>
              </p:cNvPicPr>
              <p:nvPr/>
            </p:nvPicPr>
            <p:blipFill>
              <a:blip r:embed="rId34" cstate="print"/>
              <a:srcRect l="2625" t="4193" r="4189" b="3456"/>
              <a:stretch>
                <a:fillRect/>
              </a:stretch>
            </p:blipFill>
            <p:spPr bwMode="auto">
              <a:xfrm>
                <a:off x="2406320" y="7014408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  <p:pic>
            <p:nvPicPr>
              <p:cNvPr id="77" name="Picture 10" descr="C:\Users\Athena\Desktop\PHOTO NEW\IMG_1471.JPG"/>
              <p:cNvPicPr preferRelativeResize="0">
                <a:picLocks noChangeArrowheads="1"/>
              </p:cNvPicPr>
              <p:nvPr/>
            </p:nvPicPr>
            <p:blipFill>
              <a:blip r:embed="rId35" cstate="print"/>
              <a:srcRect l="5250" t="2737" r="4189" b="2841"/>
              <a:stretch>
                <a:fillRect/>
              </a:stretch>
            </p:blipFill>
            <p:spPr bwMode="auto">
              <a:xfrm>
                <a:off x="2406320" y="7980945"/>
                <a:ext cx="914400" cy="914400"/>
              </a:xfrm>
              <a:prstGeom prst="ellipse">
                <a:avLst/>
              </a:prstGeom>
              <a:ln w="63500" cap="rnd">
                <a:noFill/>
              </a:ln>
              <a:effectLst>
                <a:outerShdw blurRad="381000" dist="292100" dir="5400000" sx="-80000" sy="-18000" rotWithShape="0">
                  <a:srgbClr val="000000">
                    <a:alpha val="22000"/>
                  </a:srgbClr>
                </a:outerShdw>
              </a:effectLst>
              <a:scene3d>
                <a:camera prst="orthographicFront"/>
                <a:lightRig rig="contrasting" dir="t">
                  <a:rot lat="0" lon="0" rev="3000000"/>
                </a:lightRig>
              </a:scene3d>
              <a:sp3d contourW="7620">
                <a:bevelT w="95250" h="31750"/>
                <a:contourClr>
                  <a:srgbClr val="333333"/>
                </a:contourClr>
              </a:sp3d>
            </p:spPr>
          </p:pic>
        </p:grpSp>
        <p:sp>
          <p:nvSpPr>
            <p:cNvPr id="67" name="TextBox 66"/>
            <p:cNvSpPr txBox="1"/>
            <p:nvPr/>
          </p:nvSpPr>
          <p:spPr>
            <a:xfrm>
              <a:off x="542306" y="10850019"/>
              <a:ext cx="215976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3                     7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-1039830" y="9497219"/>
              <a:ext cx="2524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3564452" y="6556371"/>
            <a:ext cx="3208236" cy="2414248"/>
            <a:chOff x="2780689" y="8641799"/>
            <a:chExt cx="3208236" cy="2414248"/>
          </a:xfrm>
        </p:grpSpPr>
        <p:pic>
          <p:nvPicPr>
            <p:cNvPr id="79" name="Picture 3"/>
            <p:cNvPicPr>
              <a:picLocks noChangeAspect="1" noChangeArrowheads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27" t="9921" r="6229" b="32600"/>
            <a:stretch/>
          </p:blipFill>
          <p:spPr bwMode="auto">
            <a:xfrm>
              <a:off x="3140085" y="8662734"/>
              <a:ext cx="2848840" cy="20203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0" name="TextBox 79"/>
            <p:cNvSpPr txBox="1"/>
            <p:nvPr/>
          </p:nvSpPr>
          <p:spPr>
            <a:xfrm>
              <a:off x="3074374" y="10655937"/>
              <a:ext cx="285930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        3                                   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780689" y="8641799"/>
              <a:ext cx="483987" cy="20928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 rot="16200000">
              <a:off x="2248946" y="9563167"/>
              <a:ext cx="15906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ing Fract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880345" y="8756259"/>
              <a:ext cx="1038225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●NT</a:t>
              </a: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○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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7257" y="3266741"/>
            <a:ext cx="15613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-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888" y="6225563"/>
            <a:ext cx="15613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OV-3 spheroi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ight Bracket 85"/>
          <p:cNvSpPr/>
          <p:nvPr/>
        </p:nvSpPr>
        <p:spPr>
          <a:xfrm>
            <a:off x="6429375" y="4304063"/>
            <a:ext cx="45719" cy="1381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ight Bracket 86"/>
          <p:cNvSpPr/>
          <p:nvPr/>
        </p:nvSpPr>
        <p:spPr>
          <a:xfrm>
            <a:off x="6484620" y="4373907"/>
            <a:ext cx="62146" cy="69355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87"/>
          <p:cNvSpPr txBox="1"/>
          <p:nvPr/>
        </p:nvSpPr>
        <p:spPr>
          <a:xfrm>
            <a:off x="6365791" y="4613613"/>
            <a:ext cx="48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ight Bracket 88"/>
          <p:cNvSpPr/>
          <p:nvPr/>
        </p:nvSpPr>
        <p:spPr>
          <a:xfrm>
            <a:off x="6410325" y="7439549"/>
            <a:ext cx="45719" cy="1381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ight Bracket 89"/>
          <p:cNvSpPr/>
          <p:nvPr/>
        </p:nvSpPr>
        <p:spPr>
          <a:xfrm>
            <a:off x="6465570" y="7509393"/>
            <a:ext cx="56185" cy="49555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/>
          <p:cNvSpPr txBox="1"/>
          <p:nvPr/>
        </p:nvSpPr>
        <p:spPr>
          <a:xfrm>
            <a:off x="6356266" y="7625274"/>
            <a:ext cx="48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Group 54"/>
          <p:cNvGrpSpPr/>
          <p:nvPr/>
        </p:nvGrpSpPr>
        <p:grpSpPr>
          <a:xfrm>
            <a:off x="4017556" y="4736341"/>
            <a:ext cx="1675406" cy="876219"/>
            <a:chOff x="4017556" y="4736341"/>
            <a:chExt cx="1675406" cy="87621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7">
              <a:lum bright="3000" contrast="6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15" t="34162" r="35629" b="37726"/>
            <a:stretch/>
          </p:blipFill>
          <p:spPr>
            <a:xfrm>
              <a:off x="4063004" y="4961054"/>
              <a:ext cx="957153" cy="1907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48" t="52376" r="13111" b="31391"/>
            <a:stretch/>
          </p:blipFill>
          <p:spPr>
            <a:xfrm>
              <a:off x="4062971" y="5192136"/>
              <a:ext cx="957174" cy="1570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2" name="TextBox 91"/>
            <p:cNvSpPr txBox="1"/>
            <p:nvPr/>
          </p:nvSpPr>
          <p:spPr>
            <a:xfrm>
              <a:off x="4029019" y="4736341"/>
              <a:ext cx="13883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rl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980262" y="4877681"/>
              <a:ext cx="712700" cy="525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</a:t>
              </a:r>
            </a:p>
            <a:p>
              <a:pPr>
                <a:lnSpc>
                  <a:spcPct val="150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017556" y="5366339"/>
              <a:ext cx="14645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   96     40    %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1117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27</Words>
  <Application>Microsoft Office PowerPoint</Application>
  <PresentationFormat>On-screen Show (4:3)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eb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8</cp:revision>
  <dcterms:created xsi:type="dcterms:W3CDTF">2016-11-10T19:47:51Z</dcterms:created>
  <dcterms:modified xsi:type="dcterms:W3CDTF">2018-02-12T16:24:10Z</dcterms:modified>
</cp:coreProperties>
</file>